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2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959" autoAdjust="0"/>
    <p:restoredTop sz="94660"/>
  </p:normalViewPr>
  <p:slideViewPr>
    <p:cSldViewPr snapToGrid="0" showGuides="1">
      <p:cViewPr varScale="1">
        <p:scale>
          <a:sx n="117" d="100"/>
          <a:sy n="117" d="100"/>
        </p:scale>
        <p:origin x="-1560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7EE13-123A-4072-9286-9F30B7867094}" type="datetimeFigureOut">
              <a:rPr lang="en-GB" smtClean="0"/>
              <a:t>17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67B5-56B9-499B-8E0E-6BDFFA4CA7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64709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7EE13-123A-4072-9286-9F30B7867094}" type="datetimeFigureOut">
              <a:rPr lang="en-GB" smtClean="0"/>
              <a:t>17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67B5-56B9-499B-8E0E-6BDFFA4CA7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65227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7EE13-123A-4072-9286-9F30B7867094}" type="datetimeFigureOut">
              <a:rPr lang="en-GB" smtClean="0"/>
              <a:t>17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67B5-56B9-499B-8E0E-6BDFFA4CA7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40621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7EE13-123A-4072-9286-9F30B7867094}" type="datetimeFigureOut">
              <a:rPr lang="en-GB" smtClean="0"/>
              <a:t>17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67B5-56B9-499B-8E0E-6BDFFA4CA7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10972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7EE13-123A-4072-9286-9F30B7867094}" type="datetimeFigureOut">
              <a:rPr lang="en-GB" smtClean="0"/>
              <a:t>17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67B5-56B9-499B-8E0E-6BDFFA4CA7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515166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7EE13-123A-4072-9286-9F30B7867094}" type="datetimeFigureOut">
              <a:rPr lang="en-GB" smtClean="0"/>
              <a:t>17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67B5-56B9-499B-8E0E-6BDFFA4CA7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93208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7EE13-123A-4072-9286-9F30B7867094}" type="datetimeFigureOut">
              <a:rPr lang="en-GB" smtClean="0"/>
              <a:t>17/02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67B5-56B9-499B-8E0E-6BDFFA4CA7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94334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7EE13-123A-4072-9286-9F30B7867094}" type="datetimeFigureOut">
              <a:rPr lang="en-GB" smtClean="0"/>
              <a:t>17/02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67B5-56B9-499B-8E0E-6BDFFA4CA7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4224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7EE13-123A-4072-9286-9F30B7867094}" type="datetimeFigureOut">
              <a:rPr lang="en-GB" smtClean="0"/>
              <a:t>17/02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67B5-56B9-499B-8E0E-6BDFFA4CA7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72012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7EE13-123A-4072-9286-9F30B7867094}" type="datetimeFigureOut">
              <a:rPr lang="en-GB" smtClean="0"/>
              <a:t>17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67B5-56B9-499B-8E0E-6BDFFA4CA7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85921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7EE13-123A-4072-9286-9F30B7867094}" type="datetimeFigureOut">
              <a:rPr lang="en-GB" smtClean="0"/>
              <a:t>17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767B5-56B9-499B-8E0E-6BDFFA4CA7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7383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D7EE13-123A-4072-9286-9F30B7867094}" type="datetimeFigureOut">
              <a:rPr lang="en-GB" smtClean="0"/>
              <a:t>17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8767B5-56B9-499B-8E0E-6BDFFA4CA7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89426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552450" y="323850"/>
            <a:ext cx="40386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2 Table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2233878" y="1027410"/>
            <a:ext cx="4676244" cy="3483644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="" xmlns:a16="http://schemas.microsoft.com/office/drawing/2014/main" id="{BD434078-1521-4091-8B19-8D5F426753E4}"/>
              </a:ext>
            </a:extLst>
          </p:cNvPr>
          <p:cNvSpPr/>
          <p:nvPr/>
        </p:nvSpPr>
        <p:spPr>
          <a:xfrm>
            <a:off x="552450" y="4626470"/>
            <a:ext cx="8232775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SNIGRDCSKLFAEEISSYTDTFI</a:t>
            </a:r>
            <a:r>
              <a:rPr lang="en-GB" sz="12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TETNDSSTSTSTSQETTQSVTQQSSIWDTI</a:t>
            </a:r>
            <a:r>
              <a:rPr lang="en-GB" sz="12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YFIKNWNGPFTQGGGLIFDMVTFIVNIWLNLSD</a:t>
            </a:r>
            <a:r>
              <a:rPr lang="en-GB" sz="12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SDLQLVTSILIDFWGDEFNQVESVYRIYSNESIWQH</a:t>
            </a:r>
            <a:r>
              <a:rPr lang="en-GB" sz="12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MNGKCYCSYGGAEIESYNYEVLCESFIPG</a:t>
            </a:r>
            <a:r>
              <a:rPr lang="en-GB" sz="12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QSLEKLFCLLYPFEMEMLLNKQFNEKTTGKDLSAFIE	Mw 25650</a:t>
            </a:r>
            <a:endParaRPr lang="en-GB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sz="1200" dirty="0">
              <a:solidFill>
                <a:srgbClr val="00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sz="12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P1</a:t>
            </a:r>
            <a:r>
              <a:rPr lang="en-GB" sz="12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; MEG-n2; </a:t>
            </a:r>
            <a:r>
              <a:rPr lang="en-GB" sz="12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MEG-26.4</a:t>
            </a:r>
            <a:r>
              <a:rPr lang="en-GB" sz="12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; ANX1; </a:t>
            </a:r>
            <a:r>
              <a:rPr lang="en-GB" sz="12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ATT</a:t>
            </a:r>
            <a:r>
              <a:rPr lang="en-GB" sz="12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; ANN1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="" xmlns:a16="http://schemas.microsoft.com/office/drawing/2014/main" id="{5EDEB5F1-1851-458A-AC07-61E4C43EAD2A}"/>
              </a:ext>
            </a:extLst>
          </p:cNvPr>
          <p:cNvSpPr/>
          <p:nvPr/>
        </p:nvSpPr>
        <p:spPr>
          <a:xfrm>
            <a:off x="2890299" y="4857303"/>
            <a:ext cx="518822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="" xmlns:a16="http://schemas.microsoft.com/office/drawing/2014/main" id="{B453B377-F1F8-4FFB-B0EE-66206B6BFBE2}"/>
              </a:ext>
            </a:extLst>
          </p:cNvPr>
          <p:cNvSpPr/>
          <p:nvPr/>
        </p:nvSpPr>
        <p:spPr>
          <a:xfrm>
            <a:off x="3359425" y="5226635"/>
            <a:ext cx="542579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="" xmlns:a16="http://schemas.microsoft.com/office/drawing/2014/main" id="{196A6B80-FF57-43B6-AB1C-F7B9BA0B8F81}"/>
              </a:ext>
            </a:extLst>
          </p:cNvPr>
          <p:cNvSpPr/>
          <p:nvPr/>
        </p:nvSpPr>
        <p:spPr>
          <a:xfrm>
            <a:off x="3843070" y="5533960"/>
            <a:ext cx="27764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="" xmlns:a16="http://schemas.microsoft.com/office/drawing/2014/main" id="{3FAB7C6F-EBE1-4F32-B3FA-AB4B236C2097}"/>
              </a:ext>
            </a:extLst>
          </p:cNvPr>
          <p:cNvSpPr txBox="1"/>
          <p:nvPr/>
        </p:nvSpPr>
        <p:spPr>
          <a:xfrm>
            <a:off x="1550504" y="667405"/>
            <a:ext cx="2782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="" xmlns:a16="http://schemas.microsoft.com/office/drawing/2014/main" id="{D7DAD92E-0737-40B4-AE53-743D0BA70469}"/>
              </a:ext>
            </a:extLst>
          </p:cNvPr>
          <p:cNvSpPr txBox="1"/>
          <p:nvPr/>
        </p:nvSpPr>
        <p:spPr>
          <a:xfrm>
            <a:off x="552450" y="4199430"/>
            <a:ext cx="2782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42610788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</TotalTime>
  <Words>8</Words>
  <Application>Microsoft Office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York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n Wilson</dc:creator>
  <cp:lastModifiedBy>Roopavathy</cp:lastModifiedBy>
  <cp:revision>4</cp:revision>
  <dcterms:created xsi:type="dcterms:W3CDTF">2019-08-28T10:03:25Z</dcterms:created>
  <dcterms:modified xsi:type="dcterms:W3CDTF">2020-02-17T06:22:16Z</dcterms:modified>
</cp:coreProperties>
</file>